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32" autoAdjust="0"/>
    <p:restoredTop sz="94660"/>
  </p:normalViewPr>
  <p:slideViewPr>
    <p:cSldViewPr snapToGrid="0">
      <p:cViewPr varScale="1">
        <p:scale>
          <a:sx n="140" d="100"/>
          <a:sy n="140" d="100"/>
        </p:scale>
        <p:origin x="232" y="9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BF9879-2120-46C2-95CF-DC687830A4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E90F57E-8760-4AB6-BD6E-2B03F4C99D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6B6061-AA8D-4200-8C53-9317D716B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A5A76C-FAF0-4F7A-AEE6-13D96F1BB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716B31-6359-41C9-9F8A-E5890AE9A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0834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A3C64-952F-42A4-B723-051BBDA05A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023CCF-D161-4F15-B31E-D2631A4D4C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56C91D-A412-41AF-8B2F-DFDE6BEE3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B5AD10-494A-4D2D-8D33-6EE7CBFD9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F6898A-3D46-403B-B3A2-59EF3AA01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6883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9113F94-64CE-44D1-B22E-9774872239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75CED9-C872-47A3-A317-B938AB6E0D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058A06-BD44-4C1D-AF3B-E52265843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7EA226-C99E-4EE2-801E-20676D39E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84F20F-22ED-49D6-9600-81953FDDEF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7380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39CAE-1803-46BF-96C6-87389A823A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A67798-118D-4085-92D1-E057CC9F16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653B5-2574-4C15-A2E0-B136510B2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53FF37-2630-4F5A-8C9A-11669428C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900E51-0F56-49BD-8F7C-3998D34F3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550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E5464-558C-4F9E-AE14-B523CBAAB5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BB2680-78F3-4330-8228-06232D1263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42D2DA-C4A2-44E5-8A2D-A0D23CC8A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FE690A-2187-4ADD-9761-1A5916B69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905A8-C341-41EB-A615-A47E8443C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1760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486F0A-421D-42F5-8688-527FEEA061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BC6C11-9FA0-4C0D-A6AE-3294D45799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EF9D4D-EF55-46E4-854F-C732E6AB9D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194EB3-F5F1-40CD-BBEC-E9C5EC834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2D2824-9F74-4F9D-BC7E-6305DEB77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B0537F-58C4-4AEE-96EF-D4764C637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903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DD50B3-9381-46FF-B0C3-CFA217B09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C35600-F81C-47E6-8784-0113EF98EC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DB9EA4-CC5E-4979-82E5-25156C9539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01705A-CC09-42C8-95A4-106875F520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048032-53E8-4547-9D5D-1E91AAFBA2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3FDAA4-38AB-4B16-B7FE-D74677F8E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BA44DF1-6DF7-4342-A7AD-73779F7DF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6CFC6F3-F76D-48F0-B4BF-DF347CAF2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278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0ED9EF-51C3-4249-A16A-4C1C00DA8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FCE704-4AAE-48B7-83BB-C15CBEA30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5BBBF9-67AB-45BD-8E61-30F186099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F38A45-5554-4A6D-801B-8CF5C1A9A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7492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6D8434-752E-468A-8995-85EA8AD85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04FED7-FDEC-4B8A-A514-373B95635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90514E-F2FB-43F5-BBED-7055CFAF0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0714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925469-B026-4F0C-AE4D-9E2F51B81A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249997-CA78-42C8-9BAA-C685B2A60D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E5C9E0-DB58-4692-A33E-316B4CA516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553231-5D20-4969-B227-7D18FF843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8F811C-1B92-44F1-B27D-DFBBC7498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DD1F36-2E03-400F-8BD1-0CC3A0FE7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7672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6E5EB9-A759-4E44-A4B5-60DA202F3E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5FE5172-C6A1-4049-9BCB-7C4D6A4719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7858BF-70BF-410F-91BB-37FFE76B34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B773BA-C7DA-4A39-9E89-19F3D7586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C4EFD6-2626-4B01-9F02-E98F1C1F9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F75ABE-20E3-4046-A23A-9DD3DA3E39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675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68F553-7311-4692-B099-78E01B52C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54C480-0BC7-4277-9422-91E7500873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C2D0C4-52C5-4F55-8043-287CEC775C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F2130D-4DD0-44C8-B868-8701705F9D8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C17C9F-B900-4026-B508-B4C2F035E2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B7520E-34A2-436E-AFEC-1F02832760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1DFCB-ED0A-4217-840F-252A3EB8CD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2442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208B6B5-66FC-4906-985C-AE3D39D7C510}"/>
              </a:ext>
            </a:extLst>
          </p:cNvPr>
          <p:cNvSpPr txBox="1"/>
          <p:nvPr/>
        </p:nvSpPr>
        <p:spPr>
          <a:xfrm>
            <a:off x="235131" y="5717195"/>
            <a:ext cx="1195686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/>
              <a:t>Supplementary </a:t>
            </a:r>
            <a:r>
              <a:rPr lang="en-GB" sz="1200" b="1" dirty="0"/>
              <a:t>Figure 7: </a:t>
            </a:r>
            <a:r>
              <a:rPr lang="en-GB" sz="1200" dirty="0"/>
              <a:t>Expression of the top 50 lettuce genes whose expression is correlated with </a:t>
            </a:r>
            <a:r>
              <a:rPr lang="en-GB" sz="1200" i="1" dirty="0"/>
              <a:t>S. </a:t>
            </a:r>
            <a:r>
              <a:rPr lang="en-GB" sz="1200" i="1" dirty="0" err="1"/>
              <a:t>sclerotiorum</a:t>
            </a:r>
            <a:r>
              <a:rPr lang="en-GB" sz="1200" i="1" dirty="0"/>
              <a:t> </a:t>
            </a:r>
            <a:r>
              <a:rPr lang="en-GB" sz="1200" dirty="0"/>
              <a:t>lesion size, and which were classified as non-NLR pathogen recognition receptors (</a:t>
            </a:r>
            <a:r>
              <a:rPr lang="en-GB" sz="1200" dirty="0" err="1"/>
              <a:t>Christopoulou</a:t>
            </a:r>
            <a:r>
              <a:rPr lang="en-GB" sz="1200" dirty="0"/>
              <a:t> et al 2015 classification indicated in the column </a:t>
            </a:r>
            <a:r>
              <a:rPr lang="en-GB" sz="1200" dirty="0" err="1"/>
              <a:t>gene.class</a:t>
            </a:r>
            <a:r>
              <a:rPr lang="en-GB" sz="1200" dirty="0"/>
              <a:t>). This classification was based on the presence of any combination of the following domains; leucine-rich repeats (LRR), nucleotide-binding (NB), NB Coiled-coil type (Nc), transmembrane (TM), kinase, non-arginine-aspartate kinase (non-RD kinase) and</a:t>
            </a:r>
            <a:r>
              <a:rPr lang="es-ES" sz="1200" dirty="0"/>
              <a:t> TOLL/interleukin-1 receptor (TIR). </a:t>
            </a:r>
            <a:r>
              <a:rPr lang="es-ES" sz="1200" dirty="0" err="1"/>
              <a:t>Additional</a:t>
            </a:r>
            <a:r>
              <a:rPr lang="es-ES" sz="1200" dirty="0"/>
              <a:t> gene </a:t>
            </a:r>
            <a:r>
              <a:rPr lang="es-ES" sz="1200" dirty="0" err="1"/>
              <a:t>nomenclature</a:t>
            </a:r>
            <a:r>
              <a:rPr lang="es-ES" sz="1200" dirty="0"/>
              <a:t> </a:t>
            </a:r>
            <a:r>
              <a:rPr lang="es-ES" sz="1200" dirty="0" err="1"/>
              <a:t>includes</a:t>
            </a:r>
            <a:r>
              <a:rPr lang="es-ES" sz="1200" dirty="0"/>
              <a:t> </a:t>
            </a:r>
            <a:r>
              <a:rPr lang="es-ES" sz="1200" dirty="0" err="1"/>
              <a:t>NcL</a:t>
            </a:r>
            <a:r>
              <a:rPr lang="es-ES" sz="1200" dirty="0"/>
              <a:t>: NC plus L </a:t>
            </a:r>
            <a:r>
              <a:rPr lang="es-ES" sz="1200" dirty="0" err="1"/>
              <a:t>domains</a:t>
            </a:r>
            <a:r>
              <a:rPr lang="es-ES" sz="1200" dirty="0"/>
              <a:t>; </a:t>
            </a:r>
            <a:r>
              <a:rPr lang="es-ES" sz="1200" dirty="0" err="1"/>
              <a:t>PkinL</a:t>
            </a:r>
            <a:r>
              <a:rPr lang="es-ES" sz="1200" dirty="0"/>
              <a:t>: </a:t>
            </a:r>
            <a:r>
              <a:rPr lang="es-ES" sz="1200" dirty="0" err="1"/>
              <a:t>kinase</a:t>
            </a:r>
            <a:r>
              <a:rPr lang="es-ES" sz="1200" dirty="0"/>
              <a:t> plus L; RLK: receptor-</a:t>
            </a:r>
            <a:r>
              <a:rPr lang="es-ES" sz="1200" dirty="0" err="1"/>
              <a:t>like</a:t>
            </a:r>
            <a:r>
              <a:rPr lang="es-ES" sz="1200" dirty="0"/>
              <a:t> </a:t>
            </a:r>
            <a:r>
              <a:rPr lang="es-ES" sz="1200" dirty="0" err="1"/>
              <a:t>kinase</a:t>
            </a:r>
            <a:r>
              <a:rPr lang="es-ES" sz="1200" dirty="0"/>
              <a:t>; RLP receptor-</a:t>
            </a:r>
            <a:r>
              <a:rPr lang="es-ES" sz="1200" dirty="0" err="1"/>
              <a:t>like</a:t>
            </a:r>
            <a:r>
              <a:rPr lang="es-ES" sz="1200" dirty="0"/>
              <a:t> </a:t>
            </a:r>
            <a:r>
              <a:rPr lang="es-ES" sz="1200" dirty="0" err="1"/>
              <a:t>protein</a:t>
            </a:r>
            <a:r>
              <a:rPr lang="es-ES" sz="1200" dirty="0"/>
              <a:t>. </a:t>
            </a:r>
            <a:r>
              <a:rPr lang="en-GB" sz="1200" dirty="0"/>
              <a:t>The individual lettuce samples are ordered left to right on the basis of lesion size after inoculation with </a:t>
            </a:r>
            <a:r>
              <a:rPr lang="en-GB" sz="1200" i="1" dirty="0"/>
              <a:t>S. </a:t>
            </a:r>
            <a:r>
              <a:rPr lang="en-GB" sz="1200" i="1" dirty="0" err="1"/>
              <a:t>sclerotiorum</a:t>
            </a:r>
            <a:r>
              <a:rPr lang="en-GB" sz="1200" dirty="0"/>
              <a:t>, with the most susceptible (largest lesion size) on the left and most resistant (smallest lesion size</a:t>
            </a:r>
            <a:r>
              <a:rPr lang="en-GB" sz="1200" i="1" dirty="0"/>
              <a:t>)</a:t>
            </a:r>
            <a:r>
              <a:rPr lang="en-GB" sz="1200" dirty="0"/>
              <a:t> on the right. Log</a:t>
            </a:r>
            <a:r>
              <a:rPr lang="en-GB" sz="1200" baseline="-25000" dirty="0"/>
              <a:t>2</a:t>
            </a:r>
            <a:r>
              <a:rPr lang="en-GB" sz="1200" dirty="0"/>
              <a:t> expression is indicated by the red/blue scale. </a:t>
            </a:r>
            <a:endParaRPr lang="en-GB" sz="1200" b="1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36C35EB-7ABE-4635-B311-5D62089DB89E}"/>
              </a:ext>
            </a:extLst>
          </p:cNvPr>
          <p:cNvSpPr/>
          <p:nvPr/>
        </p:nvSpPr>
        <p:spPr>
          <a:xfrm>
            <a:off x="8515701" y="936839"/>
            <a:ext cx="235612" cy="934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97F42E16-BC53-4BAE-8C6C-E57DF821DAFE}"/>
              </a:ext>
            </a:extLst>
          </p:cNvPr>
          <p:cNvGrpSpPr/>
          <p:nvPr/>
        </p:nvGrpSpPr>
        <p:grpSpPr>
          <a:xfrm>
            <a:off x="207535" y="40075"/>
            <a:ext cx="7518114" cy="5708607"/>
            <a:chOff x="845488" y="71562"/>
            <a:chExt cx="7518114" cy="5708607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35F57EC3-2495-4728-9F00-B23027E9CB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5"/>
            <a:stretch/>
          </p:blipFill>
          <p:spPr>
            <a:xfrm>
              <a:off x="845488" y="71562"/>
              <a:ext cx="7466496" cy="5708607"/>
            </a:xfrm>
            <a:prstGeom prst="rect">
              <a:avLst/>
            </a:prstGeom>
          </p:spPr>
        </p:pic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F9990B43-A6BE-4279-9EE5-2909CA008437}"/>
                </a:ext>
              </a:extLst>
            </p:cNvPr>
            <p:cNvSpPr/>
            <p:nvPr/>
          </p:nvSpPr>
          <p:spPr>
            <a:xfrm>
              <a:off x="7269146" y="1240404"/>
              <a:ext cx="1094456" cy="41987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35A0CB06-FC51-4C18-AAA6-6C1CD1DDD5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078" r="-1"/>
            <a:stretch/>
          </p:blipFill>
          <p:spPr>
            <a:xfrm>
              <a:off x="7269146" y="1269015"/>
              <a:ext cx="616095" cy="104944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89737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178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y Pink</dc:creator>
  <cp:lastModifiedBy>Katherine Denby</cp:lastModifiedBy>
  <cp:revision>8</cp:revision>
  <dcterms:created xsi:type="dcterms:W3CDTF">2022-01-22T12:48:35Z</dcterms:created>
  <dcterms:modified xsi:type="dcterms:W3CDTF">2022-02-20T19:27:11Z</dcterms:modified>
</cp:coreProperties>
</file>